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wmf" ContentType="image/x-wmf"/>
  <Override PartName="/ppt/media/image17.jpeg" ContentType="image/jpeg"/>
  <Override PartName="/ppt/media/image16.wmf" ContentType="image/x-wmf"/>
  <Override PartName="/ppt/media/image14.wmf" ContentType="image/x-wmf"/>
  <Override PartName="/ppt/media/image9.wmf" ContentType="image/x-wmf"/>
  <Override PartName="/ppt/media/image15.wmf" ContentType="image/x-wmf"/>
  <Override PartName="/ppt/media/image1.jpeg" ContentType="image/jpeg"/>
  <Override PartName="/ppt/media/image3.jpeg" ContentType="image/jpeg"/>
  <Override PartName="/ppt/media/image6.jpeg" ContentType="image/jpeg"/>
  <Override PartName="/ppt/media/image7.wmf" ContentType="image/x-wmf"/>
  <Override PartName="/ppt/media/image12.wmf" ContentType="image/x-wmf"/>
  <Override PartName="/ppt/media/image8.wmf" ContentType="image/x-wmf"/>
  <Override PartName="/ppt/media/image5.png" ContentType="image/png"/>
  <Override PartName="/ppt/media/image13.wmf" ContentType="image/x-wmf"/>
  <Override PartName="/ppt/media/image10.wmf" ContentType="image/x-wmf"/>
  <Override PartName="/ppt/media/image4.jpeg" ContentType="image/jpeg"/>
  <Override PartName="/ppt/media/image2.png" ContentType="image/png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E5E44-57B6-4CA9-9194-9710B5CDDA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27751-AC48-4ACF-9D77-C3A8956C59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F7B05A-A4BF-4156-A179-CA556780AB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7A233-CB4A-494A-B785-685CC3A748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36CAE-01FE-4DC7-B235-3E89EF41B8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20061-6B55-4656-8452-387605ED8F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A75E9-3B00-453E-9304-8C295C6B29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D21F7-35CC-455C-BE73-969CC7D4A2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27E954-ED65-4E96-9D63-AD3D2C557E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CB6B4-71B9-4EEB-BF8C-9DFBDAE07F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E8124-7ECB-49F6-99CD-1832375B40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7FF53-BCFE-4B23-B612-BBA9EE7622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773A20-486D-4938-88FA-43F4E20955F5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8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9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10.wmf"/><Relationship Id="rId9" Type="http://schemas.openxmlformats.org/officeDocument/2006/relationships/package" Target="../embeddings/oleObject5.xlsx"/><Relationship Id="rId10" Type="http://schemas.openxmlformats.org/officeDocument/2006/relationships/image" Target="../media/image11.wmf"/><Relationship Id="rId1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2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13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14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15.wmf"/><Relationship Id="rId9" Type="http://schemas.openxmlformats.org/officeDocument/2006/relationships/package" Target="../embeddings/oleObject5.xlsx"/><Relationship Id="rId10" Type="http://schemas.openxmlformats.org/officeDocument/2006/relationships/image" Target="../media/image16.wmf"/><Relationship Id="rId1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990720" y="533520"/>
            <a:ext cx="7805520" cy="53132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.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2666880" y="1905120"/>
            <a:ext cx="3400560" cy="188568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.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.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1295280" y="1523880"/>
            <a:ext cx="6728040" cy="394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1981080" y="1219320"/>
            <a:ext cx="5283360" cy="403380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.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174000" y="481500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——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.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"/>
          <p:cNvGrpSpPr/>
          <p:nvPr/>
        </p:nvGrpSpPr>
        <p:grpSpPr>
          <a:xfrm>
            <a:off x="507960" y="1995480"/>
            <a:ext cx="8167680" cy="2925720"/>
            <a:chOff x="507960" y="1995480"/>
            <a:chExt cx="8167680" cy="2925720"/>
          </a:xfrm>
        </p:grpSpPr>
        <p:pic>
          <p:nvPicPr>
            <p:cNvPr id="52" name="" descr=""/>
            <p:cNvPicPr/>
            <p:nvPr/>
          </p:nvPicPr>
          <p:blipFill>
            <a:blip r:embed="rId1"/>
            <a:stretch/>
          </p:blipFill>
          <p:spPr>
            <a:xfrm>
              <a:off x="685800" y="2133720"/>
              <a:ext cx="7989840" cy="2787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507960" y="1995480"/>
              <a:ext cx="6026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                                         B                                           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1143000" y="1905120"/>
            <a:ext cx="6892920" cy="250668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.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380880" y="36684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"/>
          <p:cNvGrpSpPr/>
          <p:nvPr/>
        </p:nvGrpSpPr>
        <p:grpSpPr>
          <a:xfrm>
            <a:off x="200160" y="609480"/>
            <a:ext cx="8715240" cy="5614920"/>
            <a:chOff x="200160" y="609480"/>
            <a:chExt cx="8715240" cy="5614920"/>
          </a:xfrm>
        </p:grpSpPr>
        <p:graphicFrame>
          <p:nvGraphicFramePr>
            <p:cNvPr id="58" name=""/>
            <p:cNvGraphicFramePr/>
            <p:nvPr/>
          </p:nvGraphicFramePr>
          <p:xfrm>
            <a:off x="200160" y="900000"/>
            <a:ext cx="2562120" cy="258120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59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00160" y="900000"/>
                      <a:ext cx="2562120" cy="2581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0" name=""/>
            <p:cNvGraphicFramePr/>
            <p:nvPr/>
          </p:nvGraphicFramePr>
          <p:xfrm>
            <a:off x="3019680" y="766800"/>
            <a:ext cx="2523960" cy="257148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61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019680" y="766800"/>
                      <a:ext cx="2523960" cy="2571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2" name=""/>
            <p:cNvGraphicFramePr/>
            <p:nvPr/>
          </p:nvGraphicFramePr>
          <p:xfrm>
            <a:off x="5762880" y="1004760"/>
            <a:ext cx="3152520" cy="256212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63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762880" y="1004760"/>
                      <a:ext cx="3152520" cy="2562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4" name=""/>
            <p:cNvGraphicFramePr/>
            <p:nvPr/>
          </p:nvGraphicFramePr>
          <p:xfrm>
            <a:off x="428760" y="3262320"/>
            <a:ext cx="4048200" cy="2657520"/>
          </p:xfrm>
          <a:graphic>
            <a:graphicData uri="http://schemas.openxmlformats.org/presentationml/2006/ole">
              <p:oleObj progId="Excel.Sheet.12" r:id="rId7" spid="">
                <p:embed/>
                <p:pic>
                  <p:nvPicPr>
                    <p:cNvPr id="65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28760" y="3262320"/>
                      <a:ext cx="4048200" cy="2657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6" name=""/>
            <p:cNvSpPr/>
            <p:nvPr/>
          </p:nvSpPr>
          <p:spPr>
            <a:xfrm>
              <a:off x="405360" y="609480"/>
              <a:ext cx="720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                                        B                                          C       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39120" y="3262320"/>
              <a:ext cx="4402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D                                                             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68" name=""/>
            <p:cNvGraphicFramePr/>
            <p:nvPr/>
          </p:nvGraphicFramePr>
          <p:xfrm>
            <a:off x="4676760" y="3414600"/>
            <a:ext cx="4057920" cy="2809800"/>
          </p:xfrm>
          <a:graphic>
            <a:graphicData uri="http://schemas.openxmlformats.org/presentationml/2006/ole">
              <p:oleObj progId="Excel.Sheet.12" r:id="rId9" spid="">
                <p:embed/>
                <p:pic>
                  <p:nvPicPr>
                    <p:cNvPr id="69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4676760" y="3414600"/>
                      <a:ext cx="4057920" cy="2809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0" name=""/>
            <p:cNvSpPr/>
            <p:nvPr/>
          </p:nvSpPr>
          <p:spPr>
            <a:xfrm>
              <a:off x="1648080" y="143352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710000" y="12189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934080" y="1128600"/>
              <a:ext cx="914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314960" y="976320"/>
              <a:ext cx="914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391280" y="150948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734000" y="124308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934080" y="823680"/>
              <a:ext cx="129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501080" y="63504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653360" y="7873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240440" y="9396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501080" y="128088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824720" y="105228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6994800" y="158580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7439040" y="1585800"/>
              <a:ext cx="381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7439040" y="1433520"/>
              <a:ext cx="762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7439040" y="1280880"/>
              <a:ext cx="1143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059960" y="13968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472880" y="13953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7701480" y="12301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7853760" y="107784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.7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upplementary Fig.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"/>
          <p:cNvGrpSpPr/>
          <p:nvPr/>
        </p:nvGrpSpPr>
        <p:grpSpPr>
          <a:xfrm>
            <a:off x="183600" y="609480"/>
            <a:ext cx="8760240" cy="5639040"/>
            <a:chOff x="183600" y="609480"/>
            <a:chExt cx="8760240" cy="5639040"/>
          </a:xfrm>
        </p:grpSpPr>
        <p:graphicFrame>
          <p:nvGraphicFramePr>
            <p:cNvPr id="93" name=""/>
            <p:cNvGraphicFramePr/>
            <p:nvPr/>
          </p:nvGraphicFramePr>
          <p:xfrm>
            <a:off x="5791320" y="942840"/>
            <a:ext cx="3152520" cy="256248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94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5791320" y="942840"/>
                      <a:ext cx="3152520" cy="2562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95" name=""/>
            <p:cNvGraphicFramePr/>
            <p:nvPr/>
          </p:nvGraphicFramePr>
          <p:xfrm>
            <a:off x="228600" y="3352680"/>
            <a:ext cx="4048200" cy="265752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96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228600" y="3352680"/>
                      <a:ext cx="4048200" cy="2657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7" name=""/>
            <p:cNvSpPr/>
            <p:nvPr/>
          </p:nvSpPr>
          <p:spPr>
            <a:xfrm>
              <a:off x="183600" y="3124080"/>
              <a:ext cx="4402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D                                                             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98" name=""/>
            <p:cNvGraphicFramePr/>
            <p:nvPr/>
          </p:nvGraphicFramePr>
          <p:xfrm>
            <a:off x="4419720" y="3438360"/>
            <a:ext cx="4057560" cy="281016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99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4419720" y="3438360"/>
                      <a:ext cx="4057560" cy="2810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00" name=""/>
            <p:cNvSpPr/>
            <p:nvPr/>
          </p:nvSpPr>
          <p:spPr>
            <a:xfrm>
              <a:off x="7164720" y="12333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7054920" y="1103400"/>
              <a:ext cx="129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7621920" y="9144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7545600" y="12193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7543800" y="1447920"/>
              <a:ext cx="32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7147080" y="1447920"/>
              <a:ext cx="320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8229600" y="1447920"/>
              <a:ext cx="32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8244000" y="12319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7391520" y="1282680"/>
              <a:ext cx="129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7926480" y="106668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10" name=""/>
            <p:cNvGraphicFramePr/>
            <p:nvPr/>
          </p:nvGraphicFramePr>
          <p:xfrm>
            <a:off x="409680" y="771480"/>
            <a:ext cx="2562120" cy="2581200"/>
          </p:xfrm>
          <a:graphic>
            <a:graphicData uri="http://schemas.openxmlformats.org/presentationml/2006/ole">
              <p:oleObj progId="Excel.Sheet.12" r:id="rId7" spid="">
                <p:embed/>
                <p:pic>
                  <p:nvPicPr>
                    <p:cNvPr id="111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09680" y="771480"/>
                      <a:ext cx="2562120" cy="2581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12" name=""/>
            <p:cNvSpPr/>
            <p:nvPr/>
          </p:nvSpPr>
          <p:spPr>
            <a:xfrm>
              <a:off x="205200" y="623880"/>
              <a:ext cx="720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                                        B                                          C       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13" name=""/>
            <p:cNvGraphicFramePr/>
            <p:nvPr/>
          </p:nvGraphicFramePr>
          <p:xfrm>
            <a:off x="3191040" y="609480"/>
            <a:ext cx="2523960" cy="2571840"/>
          </p:xfrm>
          <a:graphic>
            <a:graphicData uri="http://schemas.openxmlformats.org/presentationml/2006/ole">
              <p:oleObj progId="Excel.Sheet.12" r:id="rId9" spid="">
                <p:embed/>
                <p:pic>
                  <p:nvPicPr>
                    <p:cNvPr id="114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3191040" y="609480"/>
                      <a:ext cx="2523960" cy="2571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"/>
          <p:cNvSpPr/>
          <p:nvPr/>
        </p:nvSpPr>
        <p:spPr>
          <a:xfrm>
            <a:off x="61920" y="6384960"/>
            <a:ext cx="26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000" spc="-1" strike="noStrike">
                <a:solidFill>
                  <a:srgbClr val="000000"/>
                </a:solidFill>
                <a:latin typeface="Arial"/>
              </a:rPr>
              <a:t>Supplementary Fig.9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6" name="" descr=""/>
          <p:cNvPicPr/>
          <p:nvPr/>
        </p:nvPicPr>
        <p:blipFill>
          <a:blip r:embed="rId1"/>
          <a:stretch/>
        </p:blipFill>
        <p:spPr>
          <a:xfrm>
            <a:off x="1981080" y="2590920"/>
            <a:ext cx="4808520" cy="150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08T16:18:15Z</dcterms:created>
  <dc:creator>Jesn</dc:creator>
  <dc:description/>
  <dc:language>en-US</dc:language>
  <cp:lastModifiedBy>???</cp:lastModifiedBy>
  <dcterms:modified xsi:type="dcterms:W3CDTF">2015-08-17T03:45:36Z</dcterms:modified>
  <cp:revision>11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